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88825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606" y="-96"/>
      </p:cViewPr>
      <p:guideLst>
        <p:guide orient="horz" pos="2160"/>
        <p:guide pos="38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esearch\&#23398;&#29983;\&#32831;&#37995;\&#24037;&#20316;&#31807;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&#24037;&#20316;&#31807;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1520735802684302"/>
          <c:y val="5.1627356173014338E-2"/>
          <c:w val="0.62814901956987268"/>
          <c:h val="0.602612743709646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L$7:$L$8</c:f>
                <c:numCache>
                  <c:formatCode>General</c:formatCode>
                  <c:ptCount val="2"/>
                  <c:pt idx="0">
                    <c:v>0.7</c:v>
                  </c:pt>
                  <c:pt idx="1">
                    <c:v>0.5</c:v>
                  </c:pt>
                </c:numCache>
              </c:numRef>
            </c:plus>
            <c:minus>
              <c:numRef>
                <c:f>Sheet5!$L$7:$L$8</c:f>
                <c:numCache>
                  <c:formatCode>General</c:formatCode>
                  <c:ptCount val="2"/>
                  <c:pt idx="0">
                    <c:v>0.7</c:v>
                  </c:pt>
                  <c:pt idx="1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J$7:$J$8</c:f>
              <c:strCache>
                <c:ptCount val="2"/>
                <c:pt idx="0">
                  <c:v>Control</c:v>
                </c:pt>
                <c:pt idx="1">
                  <c:v>ABA treatment</c:v>
                </c:pt>
              </c:strCache>
            </c:strRef>
          </c:cat>
          <c:val>
            <c:numRef>
              <c:f>Sheet5!$K$7:$K$8</c:f>
              <c:numCache>
                <c:formatCode>General</c:formatCode>
                <c:ptCount val="2"/>
                <c:pt idx="0">
                  <c:v>8.3000000000000007</c:v>
                </c:pt>
                <c:pt idx="1">
                  <c:v>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93E-4354-BF63-182CC75FEC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8219136"/>
        <c:axId val="38336768"/>
      </c:barChart>
      <c:catAx>
        <c:axId val="3821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ea"/>
                <a:ea typeface="+mn-ea"/>
                <a:cs typeface="+mn-cs"/>
              </a:defRPr>
            </a:pPr>
            <a:endParaRPr lang="en-US"/>
          </a:p>
        </c:txPr>
        <c:crossAx val="38336768"/>
        <c:crosses val="autoZero"/>
        <c:auto val="1"/>
        <c:lblAlgn val="ctr"/>
        <c:lblOffset val="100"/>
        <c:noMultiLvlLbl val="0"/>
      </c:catAx>
      <c:valAx>
        <c:axId val="38336768"/>
        <c:scaling>
          <c:orientation val="minMax"/>
          <c:max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ea"/>
                    <a:ea typeface="+mn-ea"/>
                    <a:cs typeface="+mn-cs"/>
                  </a:defRPr>
                </a:pPr>
                <a:r>
                  <a:rPr lang="en-US" altLang="zh-CN" sz="1200" i="0">
                    <a:solidFill>
                      <a:schemeClr val="tx1"/>
                    </a:solidFill>
                    <a:latin typeface="+mn-ea"/>
                    <a:ea typeface="+mn-ea"/>
                  </a:rPr>
                  <a:t>Number</a:t>
                </a:r>
                <a:r>
                  <a:rPr lang="en-US" altLang="zh-CN" sz="1200" i="0" baseline="0">
                    <a:solidFill>
                      <a:schemeClr val="tx1"/>
                    </a:solidFill>
                    <a:latin typeface="+mn-ea"/>
                    <a:ea typeface="+mn-ea"/>
                  </a:rPr>
                  <a:t> of LVBs</a:t>
                </a:r>
                <a:endParaRPr lang="en-US" altLang="zh-CN" sz="1200" i="0">
                  <a:solidFill>
                    <a:schemeClr val="tx1"/>
                  </a:solidFill>
                  <a:latin typeface="+mn-ea"/>
                  <a:ea typeface="+mn-ea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ea"/>
                <a:ea typeface="+mn-ea"/>
                <a:cs typeface="+mn-cs"/>
              </a:defRPr>
            </a:pPr>
            <a:endParaRPr lang="en-US"/>
          </a:p>
        </c:txPr>
        <c:crossAx val="382191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:$C$3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</c:v>
                  </c:pt>
                </c:numCache>
              </c:numRef>
            </c:plus>
            <c:minus>
              <c:numRef>
                <c:f>Sheet1!$C$2:$C$3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ontrol</c:v>
                </c:pt>
                <c:pt idx="1">
                  <c:v>ABA treatment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.54</c:v>
                </c:pt>
                <c:pt idx="1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3C8-493E-844C-92BDAD7E75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69550592"/>
        <c:axId val="174208896"/>
      </c:barChart>
      <c:catAx>
        <c:axId val="169550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208896"/>
        <c:crosses val="autoZero"/>
        <c:auto val="1"/>
        <c:lblAlgn val="ctr"/>
        <c:lblOffset val="100"/>
        <c:noMultiLvlLbl val="0"/>
      </c:catAx>
      <c:valAx>
        <c:axId val="1742088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Relative expression level of </a:t>
                </a:r>
                <a:r>
                  <a:rPr lang="en-US" i="1" dirty="0"/>
                  <a:t>OsAP2-39</a:t>
                </a:r>
                <a:endParaRPr lang="zh-CN" i="1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55059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082D18-54E8-4B7E-AA29-6502995CE500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30058E-16C6-44D3-9AC7-9C6C499BD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583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2130426"/>
            <a:ext cx="10360501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324" y="3886200"/>
            <a:ext cx="8532178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730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529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6898" y="274639"/>
            <a:ext cx="2742486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441" y="274639"/>
            <a:ext cx="802431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346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353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2833" y="4406901"/>
            <a:ext cx="103605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2833" y="2906713"/>
            <a:ext cx="103605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92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441" y="1600201"/>
            <a:ext cx="53833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5986" y="1600201"/>
            <a:ext cx="53833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639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535113"/>
            <a:ext cx="538551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441" y="2174875"/>
            <a:ext cx="538551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1754" y="1535113"/>
            <a:ext cx="538763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1754" y="2174875"/>
            <a:ext cx="538763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829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21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743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442" y="273050"/>
            <a:ext cx="4010039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5492" y="273051"/>
            <a:ext cx="6813892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442" y="1435101"/>
            <a:ext cx="4010039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446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095" y="4800600"/>
            <a:ext cx="7313295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095" y="612775"/>
            <a:ext cx="7313295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095" y="5367338"/>
            <a:ext cx="7313295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870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441" y="274638"/>
            <a:ext cx="10969943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600201"/>
            <a:ext cx="10969943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441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4515" y="6356351"/>
            <a:ext cx="385979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5325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857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xmlns="" id="{9CCAD57A-B0F0-448F-B0C6-ECC6F14AE4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699030"/>
              </p:ext>
            </p:extLst>
          </p:nvPr>
        </p:nvGraphicFramePr>
        <p:xfrm>
          <a:off x="1510356" y="1182758"/>
          <a:ext cx="1818386" cy="35457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2494073" y="1610140"/>
            <a:ext cx="765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/>
              <a:t>*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9BF788B7-E347-4FC3-BF26-19FE32F5D948}"/>
              </a:ext>
            </a:extLst>
          </p:cNvPr>
          <p:cNvSpPr txBox="1"/>
          <p:nvPr/>
        </p:nvSpPr>
        <p:spPr>
          <a:xfrm>
            <a:off x="382559" y="264984"/>
            <a:ext cx="3174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11: Fig S5</a:t>
            </a:r>
            <a:endParaRPr lang="zh-CN" altLang="en-US" dirty="0"/>
          </a:p>
        </p:txBody>
      </p:sp>
      <p:graphicFrame>
        <p:nvGraphicFramePr>
          <p:cNvPr id="7" name="图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4409533"/>
              </p:ext>
            </p:extLst>
          </p:nvPr>
        </p:nvGraphicFramePr>
        <p:xfrm>
          <a:off x="3556921" y="1182757"/>
          <a:ext cx="1980961" cy="3311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4675258" y="1321237"/>
            <a:ext cx="765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884499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6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DIQUE</dc:creator>
  <cp:lastModifiedBy>JADIQUE</cp:lastModifiedBy>
  <cp:revision>11</cp:revision>
  <dcterms:created xsi:type="dcterms:W3CDTF">2019-03-15T11:38:19Z</dcterms:created>
  <dcterms:modified xsi:type="dcterms:W3CDTF">2019-03-15T11:44:03Z</dcterms:modified>
</cp:coreProperties>
</file>